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4" r:id="rId5"/>
    <p:sldId id="259" r:id="rId6"/>
    <p:sldId id="266" r:id="rId7"/>
    <p:sldId id="260" r:id="rId8"/>
    <p:sldId id="261" r:id="rId9"/>
    <p:sldId id="262" r:id="rId10"/>
    <p:sldId id="265" r:id="rId11"/>
    <p:sldId id="263" r:id="rId1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A3A27"/>
    <a:srgbClr val="BB3A27"/>
    <a:srgbClr val="0970B5"/>
    <a:srgbClr val="BD3C29"/>
    <a:srgbClr val="0172B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 varScale="1">
        <p:scale>
          <a:sx n="89" d="100"/>
          <a:sy n="89" d="100"/>
        </p:scale>
        <p:origin x="171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4" Type="http://schemas.openxmlformats.org/officeDocument/2006/relationships/image" Target="../media/image12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D4FD96-8A8A-43E8-A638-7E2E67FBC2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D7F4CCD-CFBB-4E73-9303-46E6800452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CE7D4E4-B70B-47D6-BB02-A051D171EA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511F1-0C61-4A17-BF66-EDC94A9CE8DE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2E1664-338D-4B80-948E-31D20D3AD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B797192-ED11-4244-AA63-F00CC4265D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C9E11-7123-4357-82B4-7ADA628532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7425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FDEBDB-5143-4085-9116-B63C7AD9F6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7A69B26-D680-4436-8B0A-47EB396813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BA8EB91-42DB-44D2-B59C-46C8512BDC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511F1-0C61-4A17-BF66-EDC94A9CE8DE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5432D56-DDDC-4746-9D01-75F4B244F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E73BC40-BB30-4F46-BDA0-0DC84A0B9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C9E11-7123-4357-82B4-7ADA628532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0063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F10EABF-B2FE-42BD-9E9C-9692B7DFB3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D665983-4B4C-4D0E-82CB-DAA48B6D37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B31415-5DCC-467E-A94C-724429BCE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511F1-0C61-4A17-BF66-EDC94A9CE8DE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5E2B49-9F88-4960-A49A-BBE2761E80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5CA915-7C05-4BAC-8D04-5CB83DF237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C9E11-7123-4357-82B4-7ADA628532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47902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1D81DF-61A0-4FBF-B3D7-1D2952CECB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DEDEC3E-2B9F-4DC1-926C-C377AF20CA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9ED7460-87FB-4734-AC0F-C0455EEB69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511F1-0C61-4A17-BF66-EDC94A9CE8DE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532BC9-DC29-4DAC-86CE-634477B4F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BD7090-B8A1-4EB6-9F3C-202753974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C9E11-7123-4357-82B4-7ADA628532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3676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4E97D1-9140-4B17-B193-9B66EF4C8A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C5442B5-C959-422E-B512-167A696217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77FF3C-1B13-4C77-9034-63D29B43E8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511F1-0C61-4A17-BF66-EDC94A9CE8DE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2374E5-DE4A-44D7-9470-B6D59DAC5C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10ED515-3F96-4201-BAC3-D822F1A2C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C9E11-7123-4357-82B4-7ADA628532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05968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C738BD-7C38-4F6F-9A52-6C6B3DC7B0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E8CA18D-CF2A-47DA-819E-F941B766BA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EE0A25D-2CC7-48EA-A3E3-2A08567095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2877327-B1E7-4D15-A8AF-D49325593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511F1-0C61-4A17-BF66-EDC94A9CE8DE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D14FFA2-6919-4BF6-95DF-A1790D92A1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76871BB-AC27-41DE-A964-322770FAF4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C9E11-7123-4357-82B4-7ADA628532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2108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FBBE79-0B6A-4BB2-9522-F0F8321F2B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F0A0F27-8033-4D74-9834-43A9825A59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A9EEEC-E948-49C9-92DE-9C515EE1F4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A3B2F5F-009F-4A87-A277-7AB3639289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1037209-F7AC-4F5C-B9B0-7C9092F320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3AE3280-4406-4FA6-8F60-5164FF0F90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511F1-0C61-4A17-BF66-EDC94A9CE8DE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74822BB-AE34-47C9-AAD0-EF339BBD5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A4C2229-3E39-4B13-B33A-9FD55119A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C9E11-7123-4357-82B4-7ADA628532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0034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A3EE45-5C6B-48D3-9401-91581C1749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3597FDC-FA3C-4792-A514-D5287B45EB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511F1-0C61-4A17-BF66-EDC94A9CE8DE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001A7A1-BB0B-4035-9924-5EAE1B9932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D4E7E2E-DCED-4B97-8A46-AF8F91A694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C9E11-7123-4357-82B4-7ADA628532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2152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1243936-876A-469B-9424-FC3AA3153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511F1-0C61-4A17-BF66-EDC94A9CE8DE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581CA18-F481-458C-ADA0-6FA3CDD2C3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59C555A-F0AD-472F-A42A-7D85B38085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C9E11-7123-4357-82B4-7ADA628532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4347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88889D-2B32-42D8-BEEB-F8C26D9FCD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B3355F0-AC5C-4F33-9DEA-0CA90028B7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68CBFF3-862A-4A8D-9005-C62F67A6D9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730AE7D-273B-41A6-BB22-53943A714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511F1-0C61-4A17-BF66-EDC94A9CE8DE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CEE9D16-8C60-4823-B774-253CD357E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10DE8A8-B100-484A-9C7C-50F646FE1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C9E11-7123-4357-82B4-7ADA628532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2284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E95D85-FE7F-43D8-A1B4-81AA1B8439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81AF265-4098-4C8F-856B-997AF16DAB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EE90391-58A1-4AE3-A2D3-5BBACB2586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F3E340D-BFC8-499B-914F-685571498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511F1-0C61-4A17-BF66-EDC94A9CE8DE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084DB78-1C96-45AE-933C-1A4177A683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8931173-6916-4513-B872-D8A7E2BC9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C9E11-7123-4357-82B4-7ADA628532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2430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716523F-B608-4DAD-BBAF-3867EFABB2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1856E6E-FC96-4B80-AE3B-5EA16BE338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B613DEC-902F-4B0A-AF96-A7B01D876F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7511F1-0C61-4A17-BF66-EDC94A9CE8DE}" type="datetimeFigureOut">
              <a:rPr lang="zh-CN" altLang="en-US" smtClean="0"/>
              <a:t>2024/8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727082-BCAD-464C-835C-105239A3A7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638226-EC82-48C4-AF14-0561DBE706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2C9E11-7123-4357-82B4-7ADA628532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033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eg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2.tiff"/><Relationship Id="rId4" Type="http://schemas.openxmlformats.org/officeDocument/2006/relationships/image" Target="../media/image3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sv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sv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2.emf"/><Relationship Id="rId4" Type="http://schemas.openxmlformats.org/officeDocument/2006/relationships/image" Target="../media/image9.emf"/><Relationship Id="rId9" Type="http://schemas.openxmlformats.org/officeDocument/2006/relationships/oleObject" Target="../embeddings/oleObject4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4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1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16.png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sv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tiff"/><Relationship Id="rId5" Type="http://schemas.openxmlformats.org/officeDocument/2006/relationships/image" Target="../media/image25.tiff"/><Relationship Id="rId4" Type="http://schemas.openxmlformats.org/officeDocument/2006/relationships/image" Target="../media/image24.tiff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形 6">
            <a:extLst>
              <a:ext uri="{FF2B5EF4-FFF2-40B4-BE49-F238E27FC236}">
                <a16:creationId xmlns:a16="http://schemas.microsoft.com/office/drawing/2014/main" id="{F6008C24-C771-4829-A62F-7A5A7F4AB2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959695" y="195351"/>
            <a:ext cx="5136305" cy="5136305"/>
          </a:xfrm>
          <a:prstGeom prst="rect">
            <a:avLst/>
          </a:prstGeom>
        </p:spPr>
      </p:pic>
      <p:pic>
        <p:nvPicPr>
          <p:cNvPr id="9" name="图形 8">
            <a:extLst>
              <a:ext uri="{FF2B5EF4-FFF2-40B4-BE49-F238E27FC236}">
                <a16:creationId xmlns:a16="http://schemas.microsoft.com/office/drawing/2014/main" id="{E134AC6C-250E-4F5D-8D68-BBC687948C3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6273590" y="307591"/>
            <a:ext cx="5072004" cy="5072004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6BDB2817-BF1D-40BC-B811-0F1052208C5A}"/>
              </a:ext>
            </a:extLst>
          </p:cNvPr>
          <p:cNvSpPr txBox="1"/>
          <p:nvPr/>
        </p:nvSpPr>
        <p:spPr>
          <a:xfrm>
            <a:off x="2656134" y="5379595"/>
            <a:ext cx="69660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re was no difference in IARS2 transcription level between </a:t>
            </a:r>
            <a:r>
              <a:rPr lang="en-US" altLang="zh-CN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&lt;65 and </a:t>
            </a:r>
            <a:r>
              <a:rPr lang="zh-CN" altLang="en-US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≥ 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65 year-old patients or </a:t>
            </a:r>
            <a:r>
              <a:rPr lang="en-US" altLang="zh-CN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female and male patient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8AFD8FD-8244-42B1-8587-446CB586F061}"/>
              </a:ext>
            </a:extLst>
          </p:cNvPr>
          <p:cNvSpPr txBox="1"/>
          <p:nvPr/>
        </p:nvSpPr>
        <p:spPr>
          <a:xfrm>
            <a:off x="782105" y="122925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0CDB0CC-CB41-4349-A1A9-C08502C91F8C}"/>
              </a:ext>
            </a:extLst>
          </p:cNvPr>
          <p:cNvSpPr txBox="1"/>
          <p:nvPr/>
        </p:nvSpPr>
        <p:spPr>
          <a:xfrm>
            <a:off x="6009106" y="195351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883331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E513BE96-717E-417D-8EE8-EB8E61CAB2DA}"/>
              </a:ext>
            </a:extLst>
          </p:cNvPr>
          <p:cNvSpPr txBox="1"/>
          <p:nvPr/>
        </p:nvSpPr>
        <p:spPr>
          <a:xfrm>
            <a:off x="2711293" y="6155667"/>
            <a:ext cx="62121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. </a:t>
            </a:r>
            <a:r>
              <a:rPr lang="en-US" altLang="zh-CN" sz="1800" b="0" i="0" u="none" strike="noStrike" baseline="0" dirty="0">
                <a:solidFill>
                  <a:srgbClr val="231F2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r plot </a:t>
            </a:r>
            <a:r>
              <a:rPr lang="en-US" altLang="zh-CN" dirty="0">
                <a:solidFill>
                  <a:srgbClr val="231F2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owed </a:t>
            </a:r>
            <a:r>
              <a:rPr lang="en-US" altLang="zh-CN" sz="1800" b="0" i="0" u="none" strike="noStrike" baseline="0" dirty="0">
                <a:solidFill>
                  <a:srgbClr val="231F2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mmune-cell infiltration in the low-IARS2 and high-IARS2 groups based on </a:t>
            </a:r>
            <a:r>
              <a:rPr lang="en-US" altLang="zh-CN" sz="1800" b="0" i="0" u="none" strike="noStrike" baseline="0" dirty="0" err="1">
                <a:solidFill>
                  <a:srgbClr val="231F2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sGSEA</a:t>
            </a:r>
            <a:r>
              <a:rPr lang="en-US" altLang="zh-CN" sz="1800" b="0" i="0" u="none" strike="noStrike" baseline="0" dirty="0">
                <a:solidFill>
                  <a:srgbClr val="231F2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alysis.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7466AAA-BDB3-477D-981B-0C0EBF980BF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80" t="1536" b="17860"/>
          <a:stretch/>
        </p:blipFill>
        <p:spPr>
          <a:xfrm>
            <a:off x="527774" y="182880"/>
            <a:ext cx="11300236" cy="4704198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337E71C1-2BA0-4554-B574-5E9E339198BA}"/>
              </a:ext>
            </a:extLst>
          </p:cNvPr>
          <p:cNvSpPr txBox="1"/>
          <p:nvPr/>
        </p:nvSpPr>
        <p:spPr>
          <a:xfrm rot="18970228">
            <a:off x="-46728" y="5155343"/>
            <a:ext cx="11079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ctivated. B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044F754-8B98-4111-9289-99DD139071CA}"/>
              </a:ext>
            </a:extLst>
          </p:cNvPr>
          <p:cNvSpPr txBox="1"/>
          <p:nvPr/>
        </p:nvSpPr>
        <p:spPr>
          <a:xfrm rot="18926146">
            <a:off x="117221" y="5231713"/>
            <a:ext cx="13901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ctivated. CD4. T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B161FC7-ACA5-4744-881D-63027490F79A}"/>
              </a:ext>
            </a:extLst>
          </p:cNvPr>
          <p:cNvSpPr txBox="1"/>
          <p:nvPr/>
        </p:nvSpPr>
        <p:spPr>
          <a:xfrm rot="18926146">
            <a:off x="495626" y="5248592"/>
            <a:ext cx="13901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ctivated. CD8. T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F26CA26-23BD-40EA-BE7C-53A875E23ADD}"/>
              </a:ext>
            </a:extLst>
          </p:cNvPr>
          <p:cNvSpPr txBox="1"/>
          <p:nvPr/>
        </p:nvSpPr>
        <p:spPr>
          <a:xfrm rot="18926146">
            <a:off x="819274" y="5289885"/>
            <a:ext cx="14798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ctivated. dendritic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5019EB1-E639-439F-8065-45B1420CB56D}"/>
              </a:ext>
            </a:extLst>
          </p:cNvPr>
          <p:cNvSpPr txBox="1"/>
          <p:nvPr/>
        </p:nvSpPr>
        <p:spPr>
          <a:xfrm rot="18926146">
            <a:off x="908481" y="5409051"/>
            <a:ext cx="18453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D56bright. natural. killer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3BCDEBC-06C8-4DAE-8EAA-44A6F1267056}"/>
              </a:ext>
            </a:extLst>
          </p:cNvPr>
          <p:cNvSpPr txBox="1"/>
          <p:nvPr/>
        </p:nvSpPr>
        <p:spPr>
          <a:xfrm rot="18926146">
            <a:off x="1365861" y="5399686"/>
            <a:ext cx="17556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D56dim. Natural. Killer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480D802-B6C5-4DAE-80B8-40F0FB02BC86}"/>
              </a:ext>
            </a:extLst>
          </p:cNvPr>
          <p:cNvSpPr txBox="1"/>
          <p:nvPr/>
        </p:nvSpPr>
        <p:spPr>
          <a:xfrm rot="18926146">
            <a:off x="1734581" y="5394048"/>
            <a:ext cx="178125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entral. memory. CD4. T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AAEF70A-0334-4188-9ACE-E097690006F1}"/>
              </a:ext>
            </a:extLst>
          </p:cNvPr>
          <p:cNvSpPr txBox="1"/>
          <p:nvPr/>
        </p:nvSpPr>
        <p:spPr>
          <a:xfrm rot="18926146">
            <a:off x="2135956" y="5394048"/>
            <a:ext cx="178125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Central. memory. CD8. T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E9070DD-0940-49F8-98D6-1DB3BC97DA1F}"/>
              </a:ext>
            </a:extLst>
          </p:cNvPr>
          <p:cNvSpPr txBox="1"/>
          <p:nvPr/>
        </p:nvSpPr>
        <p:spPr>
          <a:xfrm rot="18926146">
            <a:off x="2487107" y="5409051"/>
            <a:ext cx="181972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Effector. memory. CD4. T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CF83A63-4AF5-4531-AC80-BB8E2A8017FE}"/>
              </a:ext>
            </a:extLst>
          </p:cNvPr>
          <p:cNvSpPr txBox="1"/>
          <p:nvPr/>
        </p:nvSpPr>
        <p:spPr>
          <a:xfrm rot="18926146">
            <a:off x="2890488" y="5404910"/>
            <a:ext cx="181972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Effector. memory. CD8. T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C7BDD8D-8B21-4A4A-AC95-D35D8BEF64BB}"/>
              </a:ext>
            </a:extLst>
          </p:cNvPr>
          <p:cNvSpPr txBox="1"/>
          <p:nvPr/>
        </p:nvSpPr>
        <p:spPr>
          <a:xfrm rot="18926146">
            <a:off x="4179176" y="5034586"/>
            <a:ext cx="7745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Eosinophi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2695DBD-D5C9-4279-A1AB-4AC2EA69CA24}"/>
              </a:ext>
            </a:extLst>
          </p:cNvPr>
          <p:cNvSpPr txBox="1"/>
          <p:nvPr/>
        </p:nvSpPr>
        <p:spPr>
          <a:xfrm rot="18926146">
            <a:off x="4106098" y="5241485"/>
            <a:ext cx="133241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amma. delta. T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2B634A2-D398-45CE-8EBE-035DE23A5800}"/>
              </a:ext>
            </a:extLst>
          </p:cNvPr>
          <p:cNvSpPr txBox="1"/>
          <p:nvPr/>
        </p:nvSpPr>
        <p:spPr>
          <a:xfrm rot="18926146">
            <a:off x="4704619" y="5159131"/>
            <a:ext cx="11079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Immature. B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BF44A06-B83E-4C6F-9C94-A500868110A1}"/>
              </a:ext>
            </a:extLst>
          </p:cNvPr>
          <p:cNvSpPr txBox="1"/>
          <p:nvPr/>
        </p:nvSpPr>
        <p:spPr>
          <a:xfrm rot="18926146">
            <a:off x="4739779" y="5290492"/>
            <a:ext cx="15119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Immature. dendritic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7176ED4-31CB-4F7A-8EFC-89435E665BFC}"/>
              </a:ext>
            </a:extLst>
          </p:cNvPr>
          <p:cNvSpPr txBox="1"/>
          <p:nvPr/>
        </p:nvSpPr>
        <p:spPr>
          <a:xfrm rot="18926146">
            <a:off x="5694136" y="5050208"/>
            <a:ext cx="8643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acrophage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B2B57B04-6937-4E7B-99AB-A8FC3F87E35A}"/>
              </a:ext>
            </a:extLst>
          </p:cNvPr>
          <p:cNvSpPr txBox="1"/>
          <p:nvPr/>
        </p:nvSpPr>
        <p:spPr>
          <a:xfrm rot="18926146">
            <a:off x="6227352" y="5002256"/>
            <a:ext cx="7040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ast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94C666CD-C840-42E4-A410-C17FF8B13B38}"/>
              </a:ext>
            </a:extLst>
          </p:cNvPr>
          <p:cNvSpPr txBox="1"/>
          <p:nvPr/>
        </p:nvSpPr>
        <p:spPr>
          <a:xfrm rot="18926146">
            <a:off x="6342610" y="5130834"/>
            <a:ext cx="10310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emory. B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A786553B-0DE9-48B4-B18E-A361BA4C083E}"/>
              </a:ext>
            </a:extLst>
          </p:cNvPr>
          <p:cNvSpPr txBox="1"/>
          <p:nvPr/>
        </p:nvSpPr>
        <p:spPr>
          <a:xfrm rot="18926146">
            <a:off x="6997805" y="5002480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onocyte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FA7E9FD-E89E-46B7-B52A-3DFBFD7FB4BF}"/>
              </a:ext>
            </a:extLst>
          </p:cNvPr>
          <p:cNvSpPr txBox="1"/>
          <p:nvPr/>
        </p:nvSpPr>
        <p:spPr>
          <a:xfrm rot="18926146">
            <a:off x="6455365" y="5390329"/>
            <a:ext cx="18421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Myeloid. derived. suppressor. cell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6E88486-05CD-45B6-8C2E-5F8F08618A51}"/>
              </a:ext>
            </a:extLst>
          </p:cNvPr>
          <p:cNvSpPr txBox="1"/>
          <p:nvPr/>
        </p:nvSpPr>
        <p:spPr>
          <a:xfrm rot="18926146">
            <a:off x="7395573" y="5180996"/>
            <a:ext cx="117211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Natural. killer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B60C561-D53E-47F1-A0CA-C67A63BC7E6A}"/>
              </a:ext>
            </a:extLst>
          </p:cNvPr>
          <p:cNvSpPr txBox="1"/>
          <p:nvPr/>
        </p:nvSpPr>
        <p:spPr>
          <a:xfrm rot="18926146">
            <a:off x="7688449" y="5239827"/>
            <a:ext cx="13067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Natural. killer. T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A85A7A6-C6FA-49FA-9C8D-5C0DBB0C30FE}"/>
              </a:ext>
            </a:extLst>
          </p:cNvPr>
          <p:cNvSpPr txBox="1"/>
          <p:nvPr/>
        </p:nvSpPr>
        <p:spPr>
          <a:xfrm rot="18926146">
            <a:off x="8549630" y="5041493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Neutrophi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6BCE746B-9B25-4BF1-A7F9-C9C30733EE6E}"/>
              </a:ext>
            </a:extLst>
          </p:cNvPr>
          <p:cNvSpPr txBox="1"/>
          <p:nvPr/>
        </p:nvSpPr>
        <p:spPr>
          <a:xfrm rot="18926146">
            <a:off x="8093188" y="5403788"/>
            <a:ext cx="17876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Plasmacytoid. Dendritic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EF51F124-C5BB-49E3-B5D0-80012CD78AAD}"/>
              </a:ext>
            </a:extLst>
          </p:cNvPr>
          <p:cNvSpPr txBox="1"/>
          <p:nvPr/>
        </p:nvSpPr>
        <p:spPr>
          <a:xfrm rot="18926146">
            <a:off x="9009077" y="5178747"/>
            <a:ext cx="117852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Regulatory. T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AB25B8FA-D32E-4BB5-8460-AD9EB101285A}"/>
              </a:ext>
            </a:extLst>
          </p:cNvPr>
          <p:cNvSpPr txBox="1"/>
          <p:nvPr/>
        </p:nvSpPr>
        <p:spPr>
          <a:xfrm rot="18926146">
            <a:off x="9150943" y="5280819"/>
            <a:ext cx="14798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T. follicular. Helper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72A59762-5B9A-47F2-A9AB-DAEF2E8A268D}"/>
              </a:ext>
            </a:extLst>
          </p:cNvPr>
          <p:cNvSpPr txBox="1"/>
          <p:nvPr/>
        </p:nvSpPr>
        <p:spPr>
          <a:xfrm rot="18926146">
            <a:off x="9645018" y="5245212"/>
            <a:ext cx="13516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Type.1. T. helper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8BA197F0-B176-4F39-AA7A-79AE5422BB37}"/>
              </a:ext>
            </a:extLst>
          </p:cNvPr>
          <p:cNvSpPr txBox="1"/>
          <p:nvPr/>
        </p:nvSpPr>
        <p:spPr>
          <a:xfrm rot="18926146">
            <a:off x="9999576" y="5263756"/>
            <a:ext cx="141577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Type.17. T. helper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8BCBAF7-45A6-46AE-9747-AA10A619A09C}"/>
              </a:ext>
            </a:extLst>
          </p:cNvPr>
          <p:cNvSpPr txBox="1"/>
          <p:nvPr/>
        </p:nvSpPr>
        <p:spPr>
          <a:xfrm rot="18926146">
            <a:off x="10428532" y="5250810"/>
            <a:ext cx="13516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Type.2. T. helper. cell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10361EF4-2542-4D31-9910-C07B63E8CE15}"/>
              </a:ext>
            </a:extLst>
          </p:cNvPr>
          <p:cNvSpPr txBox="1"/>
          <p:nvPr/>
        </p:nvSpPr>
        <p:spPr>
          <a:xfrm rot="16200000">
            <a:off x="-185951" y="2553311"/>
            <a:ext cx="8066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5F31816-5CA0-44B7-8137-87AA07A0A16A}"/>
              </a:ext>
            </a:extLst>
          </p:cNvPr>
          <p:cNvSpPr txBox="1"/>
          <p:nvPr/>
        </p:nvSpPr>
        <p:spPr>
          <a:xfrm>
            <a:off x="219294" y="461796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AE2512D-C8F9-486D-8129-000277FE21AD}"/>
              </a:ext>
            </a:extLst>
          </p:cNvPr>
          <p:cNvSpPr txBox="1"/>
          <p:nvPr/>
        </p:nvSpPr>
        <p:spPr>
          <a:xfrm>
            <a:off x="217364" y="361464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0.50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87AECBE5-4B22-4CD4-9DDD-478A104CA23B}"/>
              </a:ext>
            </a:extLst>
          </p:cNvPr>
          <p:cNvSpPr txBox="1"/>
          <p:nvPr/>
        </p:nvSpPr>
        <p:spPr>
          <a:xfrm>
            <a:off x="243578" y="256539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0.75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F91DF490-08C7-4B4D-8106-2354AE258BB1}"/>
              </a:ext>
            </a:extLst>
          </p:cNvPr>
          <p:cNvSpPr txBox="1"/>
          <p:nvPr/>
        </p:nvSpPr>
        <p:spPr>
          <a:xfrm>
            <a:off x="243484" y="154882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.00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A37676F1-0249-48E8-982F-6276DC861D0E}"/>
              </a:ext>
            </a:extLst>
          </p:cNvPr>
          <p:cNvSpPr txBox="1"/>
          <p:nvPr/>
        </p:nvSpPr>
        <p:spPr>
          <a:xfrm>
            <a:off x="217364" y="51222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090174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组合 19">
            <a:extLst>
              <a:ext uri="{FF2B5EF4-FFF2-40B4-BE49-F238E27FC236}">
                <a16:creationId xmlns:a16="http://schemas.microsoft.com/office/drawing/2014/main" id="{3855B2EB-FED8-4F9E-953E-DC73A6375E03}"/>
              </a:ext>
            </a:extLst>
          </p:cNvPr>
          <p:cNvGrpSpPr/>
          <p:nvPr/>
        </p:nvGrpSpPr>
        <p:grpSpPr>
          <a:xfrm>
            <a:off x="2820170" y="170784"/>
            <a:ext cx="5365996" cy="5296335"/>
            <a:chOff x="2327801" y="564680"/>
            <a:chExt cx="5365996" cy="5296335"/>
          </a:xfrm>
        </p:grpSpPr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DB4B6A6E-6B64-4451-B495-D30783B8D24F}"/>
                </a:ext>
              </a:extLst>
            </p:cNvPr>
            <p:cNvGrpSpPr/>
            <p:nvPr/>
          </p:nvGrpSpPr>
          <p:grpSpPr>
            <a:xfrm>
              <a:off x="3170865" y="1503212"/>
              <a:ext cx="4522932" cy="4357803"/>
              <a:chOff x="5425822" y="9656016"/>
              <a:chExt cx="2487807" cy="2396980"/>
            </a:xfrm>
          </p:grpSpPr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7D114A82-FFB8-45A3-8325-B95FB977DD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25822" y="9656016"/>
                <a:ext cx="1083600" cy="1083600"/>
              </a:xfrm>
              <a:prstGeom prst="rect">
                <a:avLst/>
              </a:prstGeom>
            </p:spPr>
          </p:pic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8C6BB5D9-73CC-4BB4-A6E0-868792788D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04277" y="9656016"/>
                <a:ext cx="1083600" cy="1083600"/>
              </a:xfrm>
              <a:prstGeom prst="rect">
                <a:avLst/>
              </a:prstGeom>
            </p:spPr>
          </p:pic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id="{9DE1A3D1-792C-4529-A69C-D732816272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25822" y="10843645"/>
                <a:ext cx="1083600" cy="1083600"/>
              </a:xfrm>
              <a:prstGeom prst="rect">
                <a:avLst/>
              </a:prstGeom>
            </p:spPr>
          </p:pic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2C959E0D-8EA9-4871-BBAE-0687D28A79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78526" y="10717893"/>
                <a:ext cx="1335103" cy="1335103"/>
              </a:xfrm>
              <a:prstGeom prst="rect">
                <a:avLst/>
              </a:prstGeom>
            </p:spPr>
          </p:pic>
        </p:grp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15C1D1CF-983C-4F79-900C-310E3FA1F966}"/>
                </a:ext>
              </a:extLst>
            </p:cNvPr>
            <p:cNvSpPr txBox="1"/>
            <p:nvPr/>
          </p:nvSpPr>
          <p:spPr>
            <a:xfrm>
              <a:off x="3740489" y="1078146"/>
              <a:ext cx="8307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652ACC9B-5A0C-4C77-AC18-1A445550A15C}"/>
                </a:ext>
              </a:extLst>
            </p:cNvPr>
            <p:cNvSpPr txBox="1"/>
            <p:nvPr/>
          </p:nvSpPr>
          <p:spPr>
            <a:xfrm>
              <a:off x="5989630" y="1078146"/>
              <a:ext cx="9810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IARS2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82C8637A-830A-4784-87C0-0449F17E7C36}"/>
                </a:ext>
              </a:extLst>
            </p:cNvPr>
            <p:cNvSpPr txBox="1"/>
            <p:nvPr/>
          </p:nvSpPr>
          <p:spPr>
            <a:xfrm>
              <a:off x="2395080" y="2303559"/>
              <a:ext cx="84306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A1AF137C-BD98-4CFC-83AC-5D085B5A1252}"/>
                </a:ext>
              </a:extLst>
            </p:cNvPr>
            <p:cNvSpPr txBox="1"/>
            <p:nvPr/>
          </p:nvSpPr>
          <p:spPr>
            <a:xfrm>
              <a:off x="2327801" y="4462714"/>
              <a:ext cx="843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MSAB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id="{14454744-61B4-4EE8-B48C-E054BC68CFFA}"/>
                </a:ext>
              </a:extLst>
            </p:cNvPr>
            <p:cNvCxnSpPr/>
            <p:nvPr/>
          </p:nvCxnSpPr>
          <p:spPr>
            <a:xfrm>
              <a:off x="3646527" y="1024112"/>
              <a:ext cx="324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3A666956-371A-474B-AFAD-E8F1DFD3FE69}"/>
                </a:ext>
              </a:extLst>
            </p:cNvPr>
            <p:cNvSpPr txBox="1"/>
            <p:nvPr/>
          </p:nvSpPr>
          <p:spPr>
            <a:xfrm>
              <a:off x="4826009" y="564680"/>
              <a:ext cx="10143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BxPC-3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文本框 20">
            <a:extLst>
              <a:ext uri="{FF2B5EF4-FFF2-40B4-BE49-F238E27FC236}">
                <a16:creationId xmlns:a16="http://schemas.microsoft.com/office/drawing/2014/main" id="{28151E4E-1B7F-469E-8B37-90C66E93D1AF}"/>
              </a:ext>
            </a:extLst>
          </p:cNvPr>
          <p:cNvSpPr txBox="1"/>
          <p:nvPr/>
        </p:nvSpPr>
        <p:spPr>
          <a:xfrm>
            <a:off x="1731582" y="5564018"/>
            <a:ext cx="92022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1. </a:t>
            </a:r>
            <a:r>
              <a:rPr lang="en-US" altLang="zh-CN" sz="1800" b="0" i="0" u="none" strike="noStrike" baseline="0" dirty="0">
                <a:solidFill>
                  <a:srgbClr val="231F2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SAB (1 </a:t>
            </a:r>
            <a:r>
              <a:rPr lang="en-US" altLang="zh-CN" sz="1800" b="0" i="0" u="none" strike="noStrike" baseline="0" dirty="0" err="1">
                <a:solidFill>
                  <a:srgbClr val="231F2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dirty="0">
                <a:solidFill>
                  <a:srgbClr val="231F2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800" b="0" i="0" u="none" strike="noStrike" baseline="0" dirty="0">
                <a:solidFill>
                  <a:srgbClr val="231F2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eversed colony formation of IARS2 overexpressed BxPC-3 cells</a:t>
            </a:r>
          </a:p>
        </p:txBody>
      </p:sp>
    </p:spTree>
    <p:extLst>
      <p:ext uri="{BB962C8B-B14F-4D97-AF65-F5344CB8AC3E}">
        <p14:creationId xmlns:p14="http://schemas.microsoft.com/office/powerpoint/2010/main" val="26476711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形 4">
            <a:extLst>
              <a:ext uri="{FF2B5EF4-FFF2-40B4-BE49-F238E27FC236}">
                <a16:creationId xmlns:a16="http://schemas.microsoft.com/office/drawing/2014/main" id="{0F395CB5-29F1-4C46-AAAF-1FAB6419C6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33333" y="416175"/>
            <a:ext cx="5681720" cy="4767420"/>
          </a:xfrm>
          <a:prstGeom prst="rect">
            <a:avLst/>
          </a:prstGeom>
        </p:spPr>
      </p:pic>
      <p:pic>
        <p:nvPicPr>
          <p:cNvPr id="7" name="图形 6">
            <a:extLst>
              <a:ext uri="{FF2B5EF4-FFF2-40B4-BE49-F238E27FC236}">
                <a16:creationId xmlns:a16="http://schemas.microsoft.com/office/drawing/2014/main" id="{95A1E1B5-5164-4D72-8F58-8AAC7755890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6276949" y="384650"/>
            <a:ext cx="5417086" cy="4735895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E1E32861-DCB9-4264-A490-E0C6687BE005}"/>
              </a:ext>
            </a:extLst>
          </p:cNvPr>
          <p:cNvSpPr txBox="1"/>
          <p:nvPr/>
        </p:nvSpPr>
        <p:spPr>
          <a:xfrm>
            <a:off x="3324506" y="5401993"/>
            <a:ext cx="65510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tatistical analysis of EMT related proteins expression level in transfected </a:t>
            </a:r>
            <a:r>
              <a:rPr lang="en-US" altLang="zh-CN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apan-1 and </a:t>
            </a:r>
            <a:r>
              <a:rPr lang="en-US" altLang="zh-CN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BxPC-3 cells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6330D299-DED1-4B54-9FC6-C24BCF88FDC6}"/>
              </a:ext>
            </a:extLst>
          </p:cNvPr>
          <p:cNvSpPr/>
          <p:nvPr/>
        </p:nvSpPr>
        <p:spPr>
          <a:xfrm>
            <a:off x="1502980" y="809296"/>
            <a:ext cx="493986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0481B5DA-8027-4CBB-B024-B4613A0CA211}"/>
              </a:ext>
            </a:extLst>
          </p:cNvPr>
          <p:cNvSpPr/>
          <p:nvPr/>
        </p:nvSpPr>
        <p:spPr>
          <a:xfrm>
            <a:off x="1502980" y="1077310"/>
            <a:ext cx="493986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07AE199D-F23A-4758-842E-DE1BA37CE56B}"/>
              </a:ext>
            </a:extLst>
          </p:cNvPr>
          <p:cNvSpPr/>
          <p:nvPr/>
        </p:nvSpPr>
        <p:spPr>
          <a:xfrm>
            <a:off x="7304690" y="804040"/>
            <a:ext cx="493986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0F32C904-5419-47E1-8D70-333D1A160F88}"/>
              </a:ext>
            </a:extLst>
          </p:cNvPr>
          <p:cNvSpPr/>
          <p:nvPr/>
        </p:nvSpPr>
        <p:spPr>
          <a:xfrm>
            <a:off x="7184700" y="1073894"/>
            <a:ext cx="493986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3FF8767-5A86-418D-8233-C2460F3176A3}"/>
              </a:ext>
            </a:extLst>
          </p:cNvPr>
          <p:cNvSpPr txBox="1"/>
          <p:nvPr/>
        </p:nvSpPr>
        <p:spPr>
          <a:xfrm>
            <a:off x="146587" y="86097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4CED830-7C6E-427B-BC35-738E70E39D4C}"/>
              </a:ext>
            </a:extLst>
          </p:cNvPr>
          <p:cNvSpPr txBox="1"/>
          <p:nvPr/>
        </p:nvSpPr>
        <p:spPr>
          <a:xfrm>
            <a:off x="6001799" y="86097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3707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AA077392-F9E1-4380-81E2-46F62691BFDA}"/>
              </a:ext>
            </a:extLst>
          </p:cNvPr>
          <p:cNvSpPr txBox="1"/>
          <p:nvPr/>
        </p:nvSpPr>
        <p:spPr>
          <a:xfrm>
            <a:off x="1958160" y="5800742"/>
            <a:ext cx="76903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Growth curve of subcutaneous tumor of each mouse in </a:t>
            </a:r>
            <a:r>
              <a:rPr lang="en-US" altLang="zh-CN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vector group, </a:t>
            </a:r>
            <a:r>
              <a:rPr lang="en-US" altLang="zh-CN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ARS2 group, </a:t>
            </a:r>
            <a:r>
              <a:rPr lang="en-US" altLang="zh-CN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C) </a:t>
            </a:r>
            <a:r>
              <a:rPr lang="en-US" altLang="zh-CN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hCtrl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group and </a:t>
            </a:r>
            <a:r>
              <a:rPr lang="en-US" altLang="zh-CN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D)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hIARS2 group respectively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7372C641-19E8-43B4-AE91-6C6C4BAB6D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37174021"/>
              </p:ext>
            </p:extLst>
          </p:nvPr>
        </p:nvGraphicFramePr>
        <p:xfrm>
          <a:off x="1743017" y="314815"/>
          <a:ext cx="3744349" cy="29415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0" name="Prism 9" r:id="rId3" imgW="2775978" imgH="2180842" progId="Prism9.Document">
                  <p:embed/>
                </p:oleObj>
              </mc:Choice>
              <mc:Fallback>
                <p:oleObj name="Prism 9" r:id="rId3" imgW="2775978" imgH="218084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43017" y="314815"/>
                        <a:ext cx="3744349" cy="29415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0797DF41-AC76-4709-9F5A-25E5863637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0300114"/>
              </p:ext>
            </p:extLst>
          </p:nvPr>
        </p:nvGraphicFramePr>
        <p:xfrm>
          <a:off x="5596578" y="314815"/>
          <a:ext cx="3744349" cy="29415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1" name="Prism 9" r:id="rId5" imgW="2775978" imgH="2180842" progId="Prism9.Document">
                  <p:embed/>
                </p:oleObj>
              </mc:Choice>
              <mc:Fallback>
                <p:oleObj name="Prism 9" r:id="rId5" imgW="2775978" imgH="218084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596578" y="314815"/>
                        <a:ext cx="3744349" cy="29415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D7F4FE0D-4E62-4294-8BD0-0096E629A0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9293265"/>
              </p:ext>
            </p:extLst>
          </p:nvPr>
        </p:nvGraphicFramePr>
        <p:xfrm>
          <a:off x="1743017" y="2942729"/>
          <a:ext cx="3744349" cy="29415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2" name="Prism 9" r:id="rId7" imgW="2775978" imgH="2180842" progId="Prism9.Document">
                  <p:embed/>
                </p:oleObj>
              </mc:Choice>
              <mc:Fallback>
                <p:oleObj name="Prism 9" r:id="rId7" imgW="2775978" imgH="218084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743017" y="2942729"/>
                        <a:ext cx="3744349" cy="29415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6526D2E8-47BB-4CC0-AD63-61F46D1E68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6704402"/>
              </p:ext>
            </p:extLst>
          </p:nvPr>
        </p:nvGraphicFramePr>
        <p:xfrm>
          <a:off x="5596578" y="2942730"/>
          <a:ext cx="3744349" cy="29415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3" name="Prism 9" r:id="rId9" imgW="2775978" imgH="2180842" progId="Prism9.Document">
                  <p:embed/>
                </p:oleObj>
              </mc:Choice>
              <mc:Fallback>
                <p:oleObj name="Prism 9" r:id="rId9" imgW="2775978" imgH="218084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596578" y="2942730"/>
                        <a:ext cx="3744349" cy="29415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文本框 11">
            <a:extLst>
              <a:ext uri="{FF2B5EF4-FFF2-40B4-BE49-F238E27FC236}">
                <a16:creationId xmlns:a16="http://schemas.microsoft.com/office/drawing/2014/main" id="{DB17F1CF-E9E0-493C-BBCD-51237CA9229A}"/>
              </a:ext>
            </a:extLst>
          </p:cNvPr>
          <p:cNvSpPr txBox="1"/>
          <p:nvPr/>
        </p:nvSpPr>
        <p:spPr>
          <a:xfrm>
            <a:off x="1512722" y="314815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721B439-7E8B-4F71-BD89-6C1680304742}"/>
              </a:ext>
            </a:extLst>
          </p:cNvPr>
          <p:cNvSpPr txBox="1"/>
          <p:nvPr/>
        </p:nvSpPr>
        <p:spPr>
          <a:xfrm>
            <a:off x="5366283" y="314815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222FB55-5DF8-421A-8920-0E0D18F2E88C}"/>
              </a:ext>
            </a:extLst>
          </p:cNvPr>
          <p:cNvSpPr txBox="1"/>
          <p:nvPr/>
        </p:nvSpPr>
        <p:spPr>
          <a:xfrm>
            <a:off x="1512722" y="2942729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6995A3B-8F03-4811-B3BB-E0E04460CC8A}"/>
              </a:ext>
            </a:extLst>
          </p:cNvPr>
          <p:cNvSpPr txBox="1"/>
          <p:nvPr/>
        </p:nvSpPr>
        <p:spPr>
          <a:xfrm>
            <a:off x="5366283" y="2952225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92795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9" name="对象 108">
            <a:extLst>
              <a:ext uri="{FF2B5EF4-FFF2-40B4-BE49-F238E27FC236}">
                <a16:creationId xmlns:a16="http://schemas.microsoft.com/office/drawing/2014/main" id="{D4D91AC1-E2F1-4897-B79E-0C23736DE1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8507022"/>
              </p:ext>
            </p:extLst>
          </p:nvPr>
        </p:nvGraphicFramePr>
        <p:xfrm>
          <a:off x="5608054" y="1038171"/>
          <a:ext cx="3301058" cy="3163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" name="Prism 9" r:id="rId3" imgW="1927312" imgH="1837768" progId="Prism9.Document">
                  <p:embed/>
                </p:oleObj>
              </mc:Choice>
              <mc:Fallback>
                <p:oleObj name="Prism 9" r:id="rId3" imgW="1927312" imgH="183776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608054" y="1038171"/>
                        <a:ext cx="3301058" cy="3163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0" name="对象 109">
            <a:extLst>
              <a:ext uri="{FF2B5EF4-FFF2-40B4-BE49-F238E27FC236}">
                <a16:creationId xmlns:a16="http://schemas.microsoft.com/office/drawing/2014/main" id="{FF0C421A-AF45-4FA5-9BDE-38572930DF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3057935"/>
              </p:ext>
            </p:extLst>
          </p:nvPr>
        </p:nvGraphicFramePr>
        <p:xfrm>
          <a:off x="2421008" y="1038171"/>
          <a:ext cx="3301058" cy="31634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5" name="Prism 9" r:id="rId5" imgW="1927312" imgH="1837768" progId="Prism9.Document">
                  <p:embed/>
                </p:oleObj>
              </mc:Choice>
              <mc:Fallback>
                <p:oleObj name="Prism 9" r:id="rId5" imgW="1927312" imgH="183776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21008" y="1038171"/>
                        <a:ext cx="3301058" cy="31634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1" name="文本框 110">
            <a:extLst>
              <a:ext uri="{FF2B5EF4-FFF2-40B4-BE49-F238E27FC236}">
                <a16:creationId xmlns:a16="http://schemas.microsoft.com/office/drawing/2014/main" id="{5AE18820-7720-42B4-B4A7-8B2861A0CD4A}"/>
              </a:ext>
            </a:extLst>
          </p:cNvPr>
          <p:cNvSpPr txBox="1"/>
          <p:nvPr/>
        </p:nvSpPr>
        <p:spPr>
          <a:xfrm>
            <a:off x="2401106" y="4303192"/>
            <a:ext cx="68655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tatistical analysis of IARS2 protein level in </a:t>
            </a:r>
            <a:r>
              <a:rPr lang="en-US" altLang="zh-CN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BxPC-3 and </a:t>
            </a:r>
            <a:r>
              <a:rPr lang="en-US" altLang="zh-CN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PANC-1 tumor tissues. </a:t>
            </a:r>
            <a:r>
              <a:rPr lang="el-GR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GAPDH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was used as an internal control. 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0538BCA-1896-4824-AD95-0DD994547C52}"/>
              </a:ext>
            </a:extLst>
          </p:cNvPr>
          <p:cNvSpPr txBox="1"/>
          <p:nvPr/>
        </p:nvSpPr>
        <p:spPr>
          <a:xfrm>
            <a:off x="2245319" y="853505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9B6F9A5-645F-4291-B29F-26487B5E97BB}"/>
              </a:ext>
            </a:extLst>
          </p:cNvPr>
          <p:cNvSpPr txBox="1"/>
          <p:nvPr/>
        </p:nvSpPr>
        <p:spPr>
          <a:xfrm>
            <a:off x="5482505" y="853505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03185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F06AEC63-E444-4AD9-A3EA-6887D20A64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1682673"/>
              </p:ext>
            </p:extLst>
          </p:nvPr>
        </p:nvGraphicFramePr>
        <p:xfrm>
          <a:off x="8909264" y="1082854"/>
          <a:ext cx="3606293" cy="37674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Prism 9" r:id="rId3" imgW="2344807" imgH="2449037" progId="Prism9.Document">
                  <p:embed/>
                </p:oleObj>
              </mc:Choice>
              <mc:Fallback>
                <p:oleObj name="Prism 9" r:id="rId3" imgW="2344807" imgH="244903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909264" y="1082854"/>
                        <a:ext cx="3606293" cy="37674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9" name="图片 58">
            <a:extLst>
              <a:ext uri="{FF2B5EF4-FFF2-40B4-BE49-F238E27FC236}">
                <a16:creationId xmlns:a16="http://schemas.microsoft.com/office/drawing/2014/main" id="{D01EE009-8D39-49BD-9FE8-2EE1E4B6F99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5981" y="269353"/>
            <a:ext cx="8445911" cy="4759848"/>
          </a:xfrm>
          <a:prstGeom prst="rect">
            <a:avLst/>
          </a:prstGeom>
        </p:spPr>
      </p:pic>
      <p:sp>
        <p:nvSpPr>
          <p:cNvPr id="60" name="文本框 59">
            <a:extLst>
              <a:ext uri="{FF2B5EF4-FFF2-40B4-BE49-F238E27FC236}">
                <a16:creationId xmlns:a16="http://schemas.microsoft.com/office/drawing/2014/main" id="{DBA6F242-2CAA-42B7-9FB4-44699BAF58D7}"/>
              </a:ext>
            </a:extLst>
          </p:cNvPr>
          <p:cNvSpPr txBox="1"/>
          <p:nvPr/>
        </p:nvSpPr>
        <p:spPr>
          <a:xfrm>
            <a:off x="1212558" y="5366147"/>
            <a:ext cx="105832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r>
              <a:rPr lang="en-US" altLang="zh-CN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A) 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E staining of lung tissues and</a:t>
            </a:r>
            <a:r>
              <a:rPr lang="en-US" altLang="zh-CN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B)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metastasis incidence of mice in vector and IARS2 group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21313F0-234C-4403-B737-8BC7058FD9F6}"/>
              </a:ext>
            </a:extLst>
          </p:cNvPr>
          <p:cNvSpPr txBox="1"/>
          <p:nvPr/>
        </p:nvSpPr>
        <p:spPr>
          <a:xfrm>
            <a:off x="132920" y="191910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7162711-776D-41DB-9BDA-169C3DE9DAE2}"/>
              </a:ext>
            </a:extLst>
          </p:cNvPr>
          <p:cNvSpPr txBox="1"/>
          <p:nvPr/>
        </p:nvSpPr>
        <p:spPr>
          <a:xfrm>
            <a:off x="8909264" y="191910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21810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形 3">
            <a:extLst>
              <a:ext uri="{FF2B5EF4-FFF2-40B4-BE49-F238E27FC236}">
                <a16:creationId xmlns:a16="http://schemas.microsoft.com/office/drawing/2014/main" id="{29E86E65-9396-416D-B1A3-878E906FE9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200756" y="405492"/>
            <a:ext cx="2299471" cy="3323863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1FF0E3D0-F875-4BFE-AF34-43F4BB31B19E}"/>
              </a:ext>
            </a:extLst>
          </p:cNvPr>
          <p:cNvSpPr txBox="1"/>
          <p:nvPr/>
        </p:nvSpPr>
        <p:spPr>
          <a:xfrm>
            <a:off x="3831516" y="3942563"/>
            <a:ext cx="39892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Number of metastasis nodules in the lungs (n = 5 per group)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28116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6557B029-1D72-46E1-B7A9-93AA8F1E4D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8939" y="305777"/>
            <a:ext cx="3934121" cy="393412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7720E53-A8BB-4ECB-AA77-9F075466A19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363" y="305779"/>
            <a:ext cx="3934121" cy="393412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867E900-4164-456C-9234-BE92DCD967A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0514" y="305777"/>
            <a:ext cx="3934121" cy="3934121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368FACF1-DA7B-4CF1-9700-B3496BE30D01}"/>
              </a:ext>
            </a:extLst>
          </p:cNvPr>
          <p:cNvSpPr txBox="1"/>
          <p:nvPr/>
        </p:nvSpPr>
        <p:spPr>
          <a:xfrm>
            <a:off x="1357372" y="4934547"/>
            <a:ext cx="101429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</a:t>
            </a:r>
            <a:r>
              <a:rPr lang="en-US" altLang="zh-CN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SEA showed the enrichment pathway in high-IARS2 expression group of TCGA-PAAD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FE6E9E9-2F76-4857-BEC1-DD96D43E182D}"/>
              </a:ext>
            </a:extLst>
          </p:cNvPr>
          <p:cNvSpPr txBox="1"/>
          <p:nvPr/>
        </p:nvSpPr>
        <p:spPr>
          <a:xfrm>
            <a:off x="2225110" y="562708"/>
            <a:ext cx="18363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ES = 1.83</a:t>
            </a:r>
          </a:p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value = 0.008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5F3E8EB-203C-479F-AD5D-2CD581B1362B}"/>
              </a:ext>
            </a:extLst>
          </p:cNvPr>
          <p:cNvSpPr txBox="1"/>
          <p:nvPr/>
        </p:nvSpPr>
        <p:spPr>
          <a:xfrm>
            <a:off x="6226686" y="567398"/>
            <a:ext cx="18363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ES = 1.94</a:t>
            </a:r>
          </a:p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value &lt; 0.00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8C8EBE2-5690-4C6D-ACD5-EE2B787A5AAD}"/>
              </a:ext>
            </a:extLst>
          </p:cNvPr>
          <p:cNvSpPr txBox="1"/>
          <p:nvPr/>
        </p:nvSpPr>
        <p:spPr>
          <a:xfrm>
            <a:off x="10272736" y="562708"/>
            <a:ext cx="18363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ES = 1.83</a:t>
            </a:r>
          </a:p>
          <a:p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value &lt; 0.00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788029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68F642FF-BC0C-4D18-8015-106D02C1318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8326" y="549000"/>
            <a:ext cx="3200000" cy="2880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76FFEB78-3258-4F6D-AAA7-8D553503F03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941" y="549000"/>
            <a:ext cx="3200000" cy="288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B247A1D-9914-41AC-B09B-2FE0D602208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5307" y="3735290"/>
            <a:ext cx="3200000" cy="288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BD85196-6940-431E-8F45-291F52BEC90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326" y="3735290"/>
            <a:ext cx="3200000" cy="28800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E7457CC-0881-44ED-99ED-31711C1DCA9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8326" y="549000"/>
            <a:ext cx="3200000" cy="288000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1030C139-4237-49FF-A4FD-E6514945593A}"/>
              </a:ext>
            </a:extLst>
          </p:cNvPr>
          <p:cNvSpPr txBox="1"/>
          <p:nvPr/>
        </p:nvSpPr>
        <p:spPr>
          <a:xfrm>
            <a:off x="7373819" y="4097519"/>
            <a:ext cx="254450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.</a:t>
            </a:r>
            <a:r>
              <a:rPr lang="en-US" altLang="zh-CN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ARS2 was positively associated with stemness markers including, MET, FUT4, ACVR1, MTOR and KLF4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52853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>
            <a:extLst>
              <a:ext uri="{FF2B5EF4-FFF2-40B4-BE49-F238E27FC236}">
                <a16:creationId xmlns:a16="http://schemas.microsoft.com/office/drawing/2014/main" id="{FAF94CCB-7730-4D6B-8AEB-BC8896E6FF82}"/>
              </a:ext>
            </a:extLst>
          </p:cNvPr>
          <p:cNvGrpSpPr/>
          <p:nvPr/>
        </p:nvGrpSpPr>
        <p:grpSpPr>
          <a:xfrm>
            <a:off x="1064385" y="63062"/>
            <a:ext cx="9699690" cy="6653145"/>
            <a:chOff x="1064385" y="63062"/>
            <a:chExt cx="9699690" cy="6653145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C29651B0-4DF7-4E92-BA17-DA7CC360F7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665"/>
            <a:stretch/>
          </p:blipFill>
          <p:spPr>
            <a:xfrm>
              <a:off x="1064385" y="63062"/>
              <a:ext cx="9699690" cy="6263731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8C3A060F-6661-4006-94DC-AB7E86503EF5}"/>
                </a:ext>
              </a:extLst>
            </p:cNvPr>
            <p:cNvSpPr txBox="1"/>
            <p:nvPr/>
          </p:nvSpPr>
          <p:spPr>
            <a:xfrm>
              <a:off x="3167872" y="6069876"/>
              <a:ext cx="643627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9. </a:t>
              </a:r>
              <a:r>
                <a:rPr lang="en-US" altLang="zh-CN" sz="1800" b="0" i="0" u="none" strike="noStrike" baseline="0" dirty="0">
                  <a:solidFill>
                    <a:srgbClr val="231F2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iolin plot of immune-cell infiltration in the low-IARS2 and high-IARS2 groups based on </a:t>
              </a:r>
              <a:r>
                <a:rPr lang="en-US" altLang="zh-CN" sz="18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</a:rPr>
                <a:t>CIBERSORT algorithm</a:t>
              </a:r>
              <a:r>
                <a:rPr lang="en-US" altLang="zh-CN" sz="1800" b="0" i="0" u="none" strike="noStrike" baseline="0" dirty="0">
                  <a:solidFill>
                    <a:srgbClr val="231F2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</a:p>
          </p:txBody>
        </p:sp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D3D9B1B9-8480-47F1-BB54-450D83C6BB47}"/>
                </a:ext>
              </a:extLst>
            </p:cNvPr>
            <p:cNvGrpSpPr/>
            <p:nvPr/>
          </p:nvGrpSpPr>
          <p:grpSpPr>
            <a:xfrm>
              <a:off x="9222826" y="426054"/>
              <a:ext cx="563171" cy="419643"/>
              <a:chOff x="9222826" y="426054"/>
              <a:chExt cx="563171" cy="419643"/>
            </a:xfrm>
          </p:grpSpPr>
          <p:sp>
            <p:nvSpPr>
              <p:cNvPr id="4" name="矩形 3">
                <a:extLst>
                  <a:ext uri="{FF2B5EF4-FFF2-40B4-BE49-F238E27FC236}">
                    <a16:creationId xmlns:a16="http://schemas.microsoft.com/office/drawing/2014/main" id="{234C91FD-DFE1-4244-B80E-5F0A6B820114}"/>
                  </a:ext>
                </a:extLst>
              </p:cNvPr>
              <p:cNvSpPr/>
              <p:nvPr/>
            </p:nvSpPr>
            <p:spPr>
              <a:xfrm>
                <a:off x="9222828" y="488731"/>
                <a:ext cx="115613" cy="120869"/>
              </a:xfrm>
              <a:prstGeom prst="rect">
                <a:avLst/>
              </a:prstGeom>
              <a:solidFill>
                <a:srgbClr val="0970B5"/>
              </a:solidFill>
              <a:ln>
                <a:solidFill>
                  <a:srgbClr val="0970B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" name="矩形 6">
                <a:extLst>
                  <a:ext uri="{FF2B5EF4-FFF2-40B4-BE49-F238E27FC236}">
                    <a16:creationId xmlns:a16="http://schemas.microsoft.com/office/drawing/2014/main" id="{314C40C5-57F8-41F1-9E15-C484477D5F9F}"/>
                  </a:ext>
                </a:extLst>
              </p:cNvPr>
              <p:cNvSpPr/>
              <p:nvPr/>
            </p:nvSpPr>
            <p:spPr>
              <a:xfrm>
                <a:off x="9222826" y="662153"/>
                <a:ext cx="115613" cy="120869"/>
              </a:xfrm>
              <a:prstGeom prst="rect">
                <a:avLst/>
              </a:prstGeom>
              <a:solidFill>
                <a:srgbClr val="BB3A27"/>
              </a:solidFill>
              <a:ln>
                <a:solidFill>
                  <a:srgbClr val="BA3A2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D8570CC5-CF39-4B40-AEE8-48F48345523A}"/>
                  </a:ext>
                </a:extLst>
              </p:cNvPr>
              <p:cNvSpPr txBox="1"/>
              <p:nvPr/>
            </p:nvSpPr>
            <p:spPr>
              <a:xfrm>
                <a:off x="9338439" y="426054"/>
                <a:ext cx="4187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9F9514C8-6402-4BB6-95B1-D931ADF17353}"/>
                  </a:ext>
                </a:extLst>
              </p:cNvPr>
              <p:cNvSpPr txBox="1"/>
              <p:nvPr/>
            </p:nvSpPr>
            <p:spPr>
              <a:xfrm>
                <a:off x="9338439" y="599476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460181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2</TotalTime>
  <Words>465</Words>
  <Application>Microsoft Office PowerPoint</Application>
  <PresentationFormat>宽屏</PresentationFormat>
  <Paragraphs>70</Paragraphs>
  <Slides>1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7" baseType="lpstr">
      <vt:lpstr>等线</vt:lpstr>
      <vt:lpstr>等线 Light</vt:lpstr>
      <vt:lpstr>Arial</vt:lpstr>
      <vt:lpstr>Times New Roman</vt:lpstr>
      <vt:lpstr>Office 主题​​</vt:lpstr>
      <vt:lpstr>Prism 9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nyixun21@outlook.com</dc:creator>
  <cp:lastModifiedBy>jinyixun21@outlook.com</cp:lastModifiedBy>
  <cp:revision>34</cp:revision>
  <dcterms:created xsi:type="dcterms:W3CDTF">2023-09-30T05:39:04Z</dcterms:created>
  <dcterms:modified xsi:type="dcterms:W3CDTF">2024-08-09T05:25:36Z</dcterms:modified>
</cp:coreProperties>
</file>